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  <p:sldId id="263" r:id="rId4"/>
  </p:sldIdLst>
  <p:sldSz cx="6858000" cy="9144000" type="screen4x3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468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93F4-3AAA-4C79-B1E8-8BC0211F65D5}" type="datetimeFigureOut">
              <a:rPr lang="de-AT" smtClean="0"/>
              <a:t>02.05.2017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83F30-3458-4488-B5E5-4B8389F19B1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205202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93F4-3AAA-4C79-B1E8-8BC0211F65D5}" type="datetimeFigureOut">
              <a:rPr lang="de-AT" smtClean="0"/>
              <a:t>02.05.2017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83F30-3458-4488-B5E5-4B8389F19B1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452366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93F4-3AAA-4C79-B1E8-8BC0211F65D5}" type="datetimeFigureOut">
              <a:rPr lang="de-AT" smtClean="0"/>
              <a:t>02.05.2017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83F30-3458-4488-B5E5-4B8389F19B1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3049796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93F4-3AAA-4C79-B1E8-8BC0211F65D5}" type="datetimeFigureOut">
              <a:rPr lang="de-AT" smtClean="0"/>
              <a:t>02.05.2017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83F30-3458-4488-B5E5-4B8389F19B1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0971763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93F4-3AAA-4C79-B1E8-8BC0211F65D5}" type="datetimeFigureOut">
              <a:rPr lang="de-AT" smtClean="0"/>
              <a:t>02.05.2017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83F30-3458-4488-B5E5-4B8389F19B1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9684663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93F4-3AAA-4C79-B1E8-8BC0211F65D5}" type="datetimeFigureOut">
              <a:rPr lang="de-AT" smtClean="0"/>
              <a:t>02.05.2017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83F30-3458-4488-B5E5-4B8389F19B1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447452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93F4-3AAA-4C79-B1E8-8BC0211F65D5}" type="datetimeFigureOut">
              <a:rPr lang="de-AT" smtClean="0"/>
              <a:t>02.05.2017</a:t>
            </a:fld>
            <a:endParaRPr lang="de-A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83F30-3458-4488-B5E5-4B8389F19B1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13129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93F4-3AAA-4C79-B1E8-8BC0211F65D5}" type="datetimeFigureOut">
              <a:rPr lang="de-AT" smtClean="0"/>
              <a:t>02.05.2017</a:t>
            </a:fld>
            <a:endParaRPr lang="de-A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83F30-3458-4488-B5E5-4B8389F19B1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005335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93F4-3AAA-4C79-B1E8-8BC0211F65D5}" type="datetimeFigureOut">
              <a:rPr lang="de-AT" smtClean="0"/>
              <a:t>02.05.2017</a:t>
            </a:fld>
            <a:endParaRPr lang="de-A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83F30-3458-4488-B5E5-4B8389F19B1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792874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93F4-3AAA-4C79-B1E8-8BC0211F65D5}" type="datetimeFigureOut">
              <a:rPr lang="de-AT" smtClean="0"/>
              <a:t>02.05.2017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83F30-3458-4488-B5E5-4B8389F19B1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146597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1093F4-3AAA-4C79-B1E8-8BC0211F65D5}" type="datetimeFigureOut">
              <a:rPr lang="de-AT" smtClean="0"/>
              <a:t>02.05.2017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683F30-3458-4488-B5E5-4B8389F19B1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40438365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A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A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1093F4-3AAA-4C79-B1E8-8BC0211F65D5}" type="datetimeFigureOut">
              <a:rPr lang="de-AT" smtClean="0"/>
              <a:t>02.05.2017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683F30-3458-4488-B5E5-4B8389F19B1B}" type="slidenum">
              <a:rPr lang="de-AT" smtClean="0"/>
              <a:t>‹#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512327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/>
          <p:cNvSpPr txBox="1">
            <a:spLocks/>
          </p:cNvSpPr>
          <p:nvPr/>
        </p:nvSpPr>
        <p:spPr>
          <a:xfrm>
            <a:off x="1052736" y="7884368"/>
            <a:ext cx="4800600" cy="49812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de-AT" sz="1400" dirty="0" smtClean="0"/>
              <a:t>Figure S1</a:t>
            </a:r>
            <a:endParaRPr lang="de-AT" sz="1400" dirty="0"/>
          </a:p>
        </p:txBody>
      </p:sp>
      <p:sp>
        <p:nvSpPr>
          <p:cNvPr id="2" name="TextBox 1"/>
          <p:cNvSpPr txBox="1"/>
          <p:nvPr/>
        </p:nvSpPr>
        <p:spPr>
          <a:xfrm>
            <a:off x="548680" y="2627784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de-AT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5313" y="561975"/>
            <a:ext cx="5667375" cy="8020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Subtitle 2"/>
          <p:cNvSpPr txBox="1">
            <a:spLocks/>
          </p:cNvSpPr>
          <p:nvPr/>
        </p:nvSpPr>
        <p:spPr>
          <a:xfrm>
            <a:off x="1205136" y="8036768"/>
            <a:ext cx="4800600" cy="49812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de-AT" sz="1400" dirty="0" smtClean="0"/>
              <a:t>Figure S1</a:t>
            </a:r>
            <a:endParaRPr lang="de-AT" sz="1400" dirty="0"/>
          </a:p>
        </p:txBody>
      </p:sp>
    </p:spTree>
    <p:extLst>
      <p:ext uri="{BB962C8B-B14F-4D97-AF65-F5344CB8AC3E}">
        <p14:creationId xmlns:p14="http://schemas.microsoft.com/office/powerpoint/2010/main" val="27240288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btitle 2"/>
          <p:cNvSpPr txBox="1">
            <a:spLocks/>
          </p:cNvSpPr>
          <p:nvPr/>
        </p:nvSpPr>
        <p:spPr>
          <a:xfrm>
            <a:off x="978020" y="7884368"/>
            <a:ext cx="4800600" cy="49812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de-AT" sz="1400" dirty="0" smtClean="0"/>
              <a:t>Figure S2</a:t>
            </a:r>
            <a:endParaRPr lang="de-AT" sz="1400" dirty="0"/>
          </a:p>
        </p:txBody>
      </p:sp>
      <p:pic>
        <p:nvPicPr>
          <p:cNvPr id="3" name="Picture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84744" y="4026932"/>
            <a:ext cx="4320520" cy="414591"/>
          </a:xfrm>
          <a:prstGeom prst="rect">
            <a:avLst/>
          </a:prstGeom>
          <a:noFill/>
          <a:ln>
            <a:noFill/>
          </a:ln>
        </p:spPr>
      </p:pic>
      <p:grpSp>
        <p:nvGrpSpPr>
          <p:cNvPr id="5" name="Group 4"/>
          <p:cNvGrpSpPr/>
          <p:nvPr/>
        </p:nvGrpSpPr>
        <p:grpSpPr>
          <a:xfrm>
            <a:off x="1733569" y="1002596"/>
            <a:ext cx="1695391" cy="2669272"/>
            <a:chOff x="0" y="0"/>
            <a:chExt cx="2091193" cy="3244132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0101" y="0"/>
              <a:ext cx="1781092" cy="3244132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10" name="Text Box 2"/>
            <p:cNvSpPr txBox="1">
              <a:spLocks noChangeArrowheads="1"/>
            </p:cNvSpPr>
            <p:nvPr/>
          </p:nvSpPr>
          <p:spPr bwMode="auto">
            <a:xfrm>
              <a:off x="0" y="15900"/>
              <a:ext cx="314959" cy="316864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non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US" sz="1100" b="1" dirty="0" smtClean="0">
                  <a:latin typeface="Calibri"/>
                  <a:ea typeface="Calibri"/>
                  <a:cs typeface="Times New Roman"/>
                </a:rPr>
                <a:t>(a)</a:t>
              </a:r>
              <a:r>
                <a:rPr lang="en-US" sz="1100" b="1" dirty="0" smtClean="0">
                  <a:effectLst/>
                  <a:latin typeface="Calibri"/>
                  <a:ea typeface="Calibri"/>
                  <a:cs typeface="Times New Roman"/>
                </a:rPr>
                <a:t>.</a:t>
              </a:r>
              <a:endParaRPr lang="de-AT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3428960" y="971600"/>
            <a:ext cx="1287185" cy="2911316"/>
            <a:chOff x="-91407" y="0"/>
            <a:chExt cx="1633960" cy="3323645"/>
          </a:xfrm>
        </p:grpSpPr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0101" y="0"/>
              <a:ext cx="1232452" cy="3323645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" name="Text Box 2"/>
            <p:cNvSpPr txBox="1">
              <a:spLocks noChangeArrowheads="1"/>
            </p:cNvSpPr>
            <p:nvPr/>
          </p:nvSpPr>
          <p:spPr bwMode="auto">
            <a:xfrm>
              <a:off x="-91407" y="35386"/>
              <a:ext cx="307974" cy="316865"/>
            </a:xfrm>
            <a:prstGeom prst="rect">
              <a:avLst/>
            </a:prstGeom>
            <a:solidFill>
              <a:srgbClr val="FFFFFF"/>
            </a:solidFill>
            <a:ln w="9525">
              <a:noFill/>
              <a:miter lim="800000"/>
              <a:headEnd/>
              <a:tailEnd/>
            </a:ln>
          </p:spPr>
          <p:txBody>
            <a:bodyPr rot="0" vert="horz" wrap="none" lIns="91440" tIns="45720" rIns="91440" bIns="45720" anchor="t" anchorCtr="0">
              <a:noAutofit/>
            </a:bodyPr>
            <a:lstStyle/>
            <a:p>
              <a:pPr>
                <a:lnSpc>
                  <a:spcPct val="115000"/>
                </a:lnSpc>
                <a:spcAft>
                  <a:spcPts val="1000"/>
                </a:spcAft>
              </a:pPr>
              <a:r>
                <a:rPr lang="en-US" sz="1100" b="1" dirty="0" smtClean="0">
                  <a:effectLst/>
                  <a:latin typeface="Calibri"/>
                  <a:ea typeface="Calibri"/>
                  <a:cs typeface="Times New Roman"/>
                </a:rPr>
                <a:t>(b).</a:t>
              </a:r>
              <a:endParaRPr lang="de-AT" sz="1100" dirty="0">
                <a:effectLst/>
                <a:latin typeface="Calibri"/>
                <a:ea typeface="Calibri"/>
                <a:cs typeface="Times New Roman"/>
              </a:endParaRPr>
            </a:p>
          </p:txBody>
        </p:sp>
      </p:grpSp>
      <p:sp>
        <p:nvSpPr>
          <p:cNvPr id="13" name="Text Box 2"/>
          <p:cNvSpPr txBox="1">
            <a:spLocks noChangeArrowheads="1"/>
          </p:cNvSpPr>
          <p:nvPr/>
        </p:nvSpPr>
        <p:spPr bwMode="auto">
          <a:xfrm>
            <a:off x="1733454" y="3738900"/>
            <a:ext cx="255346" cy="260716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none" lIns="91440" tIns="45720" rIns="91440" bIns="45720" anchor="t" anchorCtr="0">
            <a:no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b="1" dirty="0" smtClean="0">
                <a:latin typeface="Calibri"/>
                <a:ea typeface="Calibri"/>
                <a:cs typeface="Times New Roman"/>
              </a:rPr>
              <a:t>(c)</a:t>
            </a:r>
            <a:r>
              <a:rPr lang="en-US" sz="1100" b="1" dirty="0" smtClean="0">
                <a:effectLst/>
                <a:latin typeface="Calibri"/>
                <a:ea typeface="Calibri"/>
                <a:cs typeface="Times New Roman"/>
              </a:rPr>
              <a:t>.</a:t>
            </a:r>
            <a:endParaRPr lang="de-AT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20688" y="5076056"/>
            <a:ext cx="547260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(a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S-PAGE of the purified MC10E7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Fv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1.5 and 3µg) from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chia pastor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under reducing conditions. Staining wit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omassi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rilliant Blue R-250;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-blot of the culture supernatant prior to purification. Probed with anti-c-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y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sette for yeast transformation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Fv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de-A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de-A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24557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42900" y="1345695"/>
            <a:ext cx="6172200" cy="6034617"/>
          </a:xfrm>
        </p:spPr>
        <p:txBody>
          <a:bodyPr>
            <a:normAutofit/>
          </a:bodyPr>
          <a:lstStyle/>
          <a:p>
            <a:pPr marL="0" indent="0" algn="just">
              <a:buNone/>
            </a:pP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ppendix S1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imers used for the Isolation of the heavy and light chain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DNAs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endParaRPr lang="de-A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150000"/>
              </a:lnSpc>
              <a:buNone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template-switching primer sequence was 5'-CTG GTG TGG TCG CTT GGT ATG TGG GGG [SpcC3]-3' (ZT-TSP). The 5'-adapter forward primer sequence was 5'-CTG GTG TGG TCG CTT GGT ATG TG-3' (ZTP-F). The mouse IgG kappa-chain C-region gene-specific primer sequence was 5'-CAC TCA TTC CTG TTG AAG CTC-3' (MIgGκ-GSP300). The mouse IgG gamma-chain C-region primer sequences were 5'-CAA GGC TTA CAA CCA CAA TC-3' (MIgGγ1-GSP301) and 5'-TCA TTT ACC AGG AGA GTG GGA G-3' (MIgGγ1-GSP954), for the isolation of mainly VH and full-length HC cDNA regions, respectively. The reverse PCR primer sequences for the amplification of LC cDNA were 5'-AAC ACT CAT TCC TGT TGA AGC TCT TGA C-3' (MIgGκ-R295) and 5'-GTT AAC TGC TCA CTG GAT GGT GGG AAG-3' (MIgGκ-R30). The reverse PCR primer sequences for amplification of HC cDNA were 5'-TCA TTT ACC AGG AGA GTG GGA GAG G-3' (MIgGγ1-R951) and 5'-TCT TGT CCA CCT TGG TGC TGC-3' (MIgGγ1-R266).</a:t>
            </a:r>
            <a:endParaRPr lang="de-A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de-A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60766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1</Words>
  <Application>Microsoft Office PowerPoint</Application>
  <PresentationFormat>On-screen Show (4:3)</PresentationFormat>
  <Paragraphs>9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toeger</dc:creator>
  <cp:lastModifiedBy>estoeger</cp:lastModifiedBy>
  <cp:revision>16</cp:revision>
  <cp:lastPrinted>2016-11-18T16:10:26Z</cp:lastPrinted>
  <dcterms:created xsi:type="dcterms:W3CDTF">2016-11-18T14:38:07Z</dcterms:created>
  <dcterms:modified xsi:type="dcterms:W3CDTF">2017-05-02T16:57:51Z</dcterms:modified>
</cp:coreProperties>
</file>